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8D084B-C0D7-48F9-85B9-B1D5E9300C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AB810-656A-4423-9EE1-A5DBE17258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1C5463-40DC-4FE5-8BCE-571FA5E298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DE1E09-A1E0-4482-9280-5DE7A28A33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20F60E-600A-4529-AEDE-857CEA5283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7DF06-E942-43F2-99E1-488A7C4A41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41D06F-9E63-4D27-AA9E-5979E83D0A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3EE873-E33E-48E6-B6F6-E78A11C5D0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EEDBC-E5F3-41FB-82BA-F52B014ED2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3AAD70-E06B-4A51-958D-2DD0B045FF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54692-573C-4F2C-BB19-4A09630DF2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79C6D-7DB6-4F10-9D77-7F1BCAFB76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AC25F1-8819-419C-9E02-C366316AC69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円/楕円 3"/>
          <p:cNvSpPr/>
          <p:nvPr/>
        </p:nvSpPr>
        <p:spPr>
          <a:xfrm>
            <a:off x="934920" y="1787400"/>
            <a:ext cx="3259080" cy="22035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円/楕円 4"/>
          <p:cNvSpPr/>
          <p:nvPr/>
        </p:nvSpPr>
        <p:spPr>
          <a:xfrm>
            <a:off x="2330280" y="1787400"/>
            <a:ext cx="3259440" cy="22035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テキスト ボックス 5"/>
          <p:cNvSpPr/>
          <p:nvPr/>
        </p:nvSpPr>
        <p:spPr>
          <a:xfrm>
            <a:off x="2546280" y="2627280"/>
            <a:ext cx="1440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erve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44 CDS cluster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6"/>
          <p:cNvSpPr/>
          <p:nvPr/>
        </p:nvSpPr>
        <p:spPr>
          <a:xfrm>
            <a:off x="1052640" y="2414520"/>
            <a:ext cx="18716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NA14 specifi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86 CDS cluster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n, MTn gen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14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S cluster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テキスト ボックス 7"/>
          <p:cNvSpPr/>
          <p:nvPr/>
        </p:nvSpPr>
        <p:spPr>
          <a:xfrm>
            <a:off x="4221000" y="2405160"/>
            <a:ext cx="14400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rain 17 specifi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54 CDS cluster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n, MTn gen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7 CDS cluster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テキスト ボックス 10"/>
          <p:cNvSpPr/>
          <p:nvPr/>
        </p:nvSpPr>
        <p:spPr>
          <a:xfrm>
            <a:off x="1436760" y="1434960"/>
            <a:ext cx="826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MA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797 CD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12"/>
          <p:cNvSpPr/>
          <p:nvPr/>
        </p:nvSpPr>
        <p:spPr>
          <a:xfrm>
            <a:off x="4244760" y="1434960"/>
            <a:ext cx="826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rain 1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66 CD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大かっこ 14"/>
          <p:cNvSpPr/>
          <p:nvPr/>
        </p:nvSpPr>
        <p:spPr>
          <a:xfrm>
            <a:off x="1035000" y="2879640"/>
            <a:ext cx="1182600" cy="343080"/>
          </a:xfrm>
          <a:prstGeom prst="bracketPair">
            <a:avLst>
              <a:gd name="adj" fmla="val 17129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大かっこ 15"/>
          <p:cNvSpPr/>
          <p:nvPr/>
        </p:nvSpPr>
        <p:spPr>
          <a:xfrm>
            <a:off x="4289400" y="2895480"/>
            <a:ext cx="1055880" cy="343080"/>
          </a:xfrm>
          <a:prstGeom prst="bracketPair">
            <a:avLst>
              <a:gd name="adj" fmla="val 17129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8"/>
          <p:cNvSpPr/>
          <p:nvPr/>
        </p:nvSpPr>
        <p:spPr>
          <a:xfrm>
            <a:off x="796680" y="826920"/>
            <a:ext cx="195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3T01:36:21Z</dcterms:created>
  <dc:creator>naito</dc:creator>
  <dc:description/>
  <dc:language>en-US</dc:language>
  <cp:lastModifiedBy>naito</cp:lastModifiedBy>
  <dcterms:modified xsi:type="dcterms:W3CDTF">2015-07-13T01:36:55Z</dcterms:modified>
  <cp:revision>1</cp:revision>
  <dc:subject/>
  <dc:title>PowerPoint プレゼンテーション</dc:title>
</cp:coreProperties>
</file>